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318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4639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4559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258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6218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410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4408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1418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5515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0692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463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360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2D enteriods_Zstack_mut8 h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22417" t="19723" r="18003" b="24580"/>
          <a:stretch/>
        </p:blipFill>
        <p:spPr>
          <a:xfrm>
            <a:off x="1597019" y="3097278"/>
            <a:ext cx="3343281" cy="293204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377491" y="6424436"/>
            <a:ext cx="42841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2.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grH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.T in close association with the apical surface of 2D enteroids. Scale bar = 100 µm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73878" y="6886101"/>
            <a:ext cx="12072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ical surface of 3D enteroid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597018" y="3041607"/>
            <a:ext cx="1038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deo 2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597017" y="2783407"/>
            <a:ext cx="3343284" cy="307777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1F8F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 </a:t>
            </a:r>
            <a:r>
              <a:rPr lang="en-GB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O-1 </a:t>
            </a:r>
            <a:r>
              <a:rPr lang="en-GB" sz="1400" dirty="0" err="1" smtClean="0">
                <a:solidFill>
                  <a:srgbClr val="24FF7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400" i="1" dirty="0" err="1" smtClean="0">
                <a:solidFill>
                  <a:srgbClr val="24FF7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gH</a:t>
            </a:r>
            <a:r>
              <a:rPr lang="en-GB" sz="1400" i="1" dirty="0" smtClean="0">
                <a:solidFill>
                  <a:srgbClr val="24FF7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dirty="0" smtClean="0">
                <a:solidFill>
                  <a:srgbClr val="24FF7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endParaRPr lang="en-GB" sz="1400" dirty="0">
              <a:solidFill>
                <a:srgbClr val="24FF7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828571" y="5752326"/>
            <a:ext cx="1352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al Region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857146" y="3087773"/>
            <a:ext cx="13242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ical Region </a:t>
            </a:r>
          </a:p>
        </p:txBody>
      </p:sp>
      <p:sp>
        <p:nvSpPr>
          <p:cNvPr id="9" name="Rectangle 8"/>
          <p:cNvSpPr/>
          <p:nvPr/>
        </p:nvSpPr>
        <p:spPr>
          <a:xfrm>
            <a:off x="1664637" y="5913666"/>
            <a:ext cx="201600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92193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38</Words>
  <Application>Microsoft Office PowerPoint</Application>
  <PresentationFormat>Widescreen</PresentationFormat>
  <Paragraphs>6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Sutton</dc:creator>
  <cp:lastModifiedBy>Kate Sutton</cp:lastModifiedBy>
  <cp:revision>3</cp:revision>
  <dcterms:created xsi:type="dcterms:W3CDTF">2023-07-13T17:30:29Z</dcterms:created>
  <dcterms:modified xsi:type="dcterms:W3CDTF">2023-07-13T17:35:42Z</dcterms:modified>
</cp:coreProperties>
</file>